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A7F494-50B5-4949-B5E3-A9D88F1D27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A1B201-0B58-4B39-870E-29DF5317CB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62D49-3CCA-44CA-927D-6F5EF3F1F2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390C0-B98B-459C-94F8-F2511FCF11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7BF37-F386-4F5A-8A32-2EBB8A5CC0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1E4B7E-E7F0-4666-80F6-F0C94FB2E4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90A4D-955C-4FE6-8B91-8B4067BE9F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CB98E8-3DD3-4D23-8BD6-608AA4B698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B4B46-A384-48A4-A3DF-2FED07B7FD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14F317-225D-408F-B8A9-1BAA1509E1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A33B4-D8A3-4E5E-A8A6-D70B51EC80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16B04-1E78-4B09-91A4-D1CE54690A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48F7DE-F45D-4082-BBFB-829F6F9D0811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0" descr=""/>
          <p:cNvPicPr/>
          <p:nvPr/>
        </p:nvPicPr>
        <p:blipFill>
          <a:blip r:embed="rId1"/>
          <a:stretch/>
        </p:blipFill>
        <p:spPr>
          <a:xfrm>
            <a:off x="928800" y="836640"/>
            <a:ext cx="14652360" cy="9705960"/>
          </a:xfrm>
          <a:prstGeom prst="rect">
            <a:avLst/>
          </a:prstGeom>
          <a:ln w="0">
            <a:noFill/>
          </a:ln>
        </p:spPr>
      </p:pic>
      <p:sp>
        <p:nvSpPr>
          <p:cNvPr id="42" name="Text Box 3"/>
          <p:cNvSpPr/>
          <p:nvPr/>
        </p:nvSpPr>
        <p:spPr>
          <a:xfrm>
            <a:off x="6084720" y="1413000"/>
            <a:ext cx="24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Non-ACLF w/out Hyponatrem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6084720" y="2133720"/>
            <a:ext cx="24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Non-ACLF with Hyponatrem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"/>
          <p:cNvSpPr/>
          <p:nvPr/>
        </p:nvSpPr>
        <p:spPr>
          <a:xfrm>
            <a:off x="6084720" y="3500280"/>
            <a:ext cx="24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ACLF w/out Hyponatrem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6"/>
          <p:cNvSpPr/>
          <p:nvPr/>
        </p:nvSpPr>
        <p:spPr>
          <a:xfrm>
            <a:off x="6156360" y="4653000"/>
            <a:ext cx="24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ACLF with Hyponatrem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7"/>
          <p:cNvSpPr/>
          <p:nvPr/>
        </p:nvSpPr>
        <p:spPr>
          <a:xfrm>
            <a:off x="611280" y="189000"/>
            <a:ext cx="7993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Patients with and without ACLF and Hyponatremia in the whole hospitaliz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2"/>
          <p:cNvSpPr/>
          <p:nvPr/>
        </p:nvSpPr>
        <p:spPr>
          <a:xfrm>
            <a:off x="5651640" y="2421000"/>
            <a:ext cx="331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Age-adjusted HR: 1.42; 95%IC: 0.62 – 2.2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3"/>
          <p:cNvSpPr/>
          <p:nvPr/>
        </p:nvSpPr>
        <p:spPr>
          <a:xfrm>
            <a:off x="5651640" y="3730680"/>
            <a:ext cx="331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Age-adjusted HR: 3.86; 95%IC: 3.57 – 4.1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4"/>
          <p:cNvSpPr/>
          <p:nvPr/>
        </p:nvSpPr>
        <p:spPr>
          <a:xfrm>
            <a:off x="5651640" y="4883040"/>
            <a:ext cx="331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Age-adjusted HR: 6.73; 95%IC: 6.43 – 7.0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11 Rectángulo"/>
          <p:cNvSpPr/>
          <p:nvPr/>
        </p:nvSpPr>
        <p:spPr>
          <a:xfrm>
            <a:off x="5506560" y="4000680"/>
            <a:ext cx="75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ff0000"/>
                </a:solidFill>
                <a:latin typeface="Arial"/>
              </a:rPr>
              <a:t>61.5%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12 Rectángulo"/>
          <p:cNvSpPr/>
          <p:nvPr/>
        </p:nvSpPr>
        <p:spPr>
          <a:xfrm>
            <a:off x="5363640" y="5072040"/>
            <a:ext cx="75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ff0000"/>
                </a:solidFill>
                <a:latin typeface="Arial"/>
              </a:rPr>
              <a:t>44.5%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15 Rectángulo"/>
          <p:cNvSpPr/>
          <p:nvPr/>
        </p:nvSpPr>
        <p:spPr>
          <a:xfrm>
            <a:off x="5515920" y="2643120"/>
            <a:ext cx="75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ff0000"/>
                </a:solidFill>
                <a:latin typeface="Arial"/>
              </a:rPr>
              <a:t>83.1%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16 Rectángulo"/>
          <p:cNvSpPr/>
          <p:nvPr/>
        </p:nvSpPr>
        <p:spPr>
          <a:xfrm>
            <a:off x="5774760" y="1071720"/>
            <a:ext cx="75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ff0000"/>
                </a:solidFill>
                <a:latin typeface="Arial"/>
              </a:rPr>
              <a:t>94.8%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14T10:18:29Z</dcterms:created>
  <dc:creator>mpavesi</dc:creator>
  <dc:description/>
  <dc:language>en-US</dc:language>
  <cp:lastModifiedBy>Andres</cp:lastModifiedBy>
  <dcterms:modified xsi:type="dcterms:W3CDTF">2014-11-15T08:16:31Z</dcterms:modified>
  <cp:revision>43</cp:revision>
  <dc:subject/>
  <dc:title>Diapositiva 1</dc:title>
</cp:coreProperties>
</file>